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88"/>
    <p:restoredTop sz="96337"/>
  </p:normalViewPr>
  <p:slideViewPr>
    <p:cSldViewPr snapToGrid="0" snapToObjects="1">
      <p:cViewPr varScale="1">
        <p:scale>
          <a:sx n="129" d="100"/>
          <a:sy n="129" d="100"/>
        </p:scale>
        <p:origin x="14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4441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9095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7295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60734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2232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12179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90903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9850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0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7851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98771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
第二级
第三级
第四级
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4FABD-C79B-C04C-99CA-0EF5B2E7C7DE}" type="datetimeFigureOut">
              <a:rPr kumimoji="1" lang="zh-CN" altLang="en-US" smtClean="0"/>
              <a:t>2023/3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DBC84-7F79-D147-B4B8-4CC52325B27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37382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CCB397E-DC53-764B-A580-5C257FC7CE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5074925"/>
              </p:ext>
            </p:extLst>
          </p:nvPr>
        </p:nvGraphicFramePr>
        <p:xfrm>
          <a:off x="39001" y="453608"/>
          <a:ext cx="9755998" cy="485570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2193">
                  <a:extLst>
                    <a:ext uri="{9D8B030D-6E8A-4147-A177-3AD203B41FA5}">
                      <a16:colId xmlns:a16="http://schemas.microsoft.com/office/drawing/2014/main" val="802750977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469117323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225051397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612227717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262707682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109041657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304437081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90114699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328602123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956825449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444000408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989965947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2544822242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728775436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3867012170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1568811684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450846092"/>
                    </a:ext>
                  </a:extLst>
                </a:gridCol>
                <a:gridCol w="523165">
                  <a:extLst>
                    <a:ext uri="{9D8B030D-6E8A-4147-A177-3AD203B41FA5}">
                      <a16:colId xmlns:a16="http://schemas.microsoft.com/office/drawing/2014/main" val="677922127"/>
                    </a:ext>
                  </a:extLst>
                </a:gridCol>
              </a:tblGrid>
              <a:tr h="352081"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3E2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1C4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1C4-interface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3E2:1C4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3E2:1C4</a:t>
                      </a:r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interface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3E2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3E2-interface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.1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:8H12:3E2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.2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:8H12:3E2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S2E12:3E2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S2E12:3E2</a:t>
                      </a:r>
                      <a:r>
                        <a:rPr lang="en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interface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S2X35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H12:S2X35</a:t>
                      </a:r>
                      <a:r>
                        <a:rPr lang="en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interface</a:t>
                      </a: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XMA01:3E2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</a:t>
                      </a:r>
                      <a:r>
                        <a:rPr lang="en" altLang="zh-CN" sz="7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MA01:3E2</a:t>
                      </a:r>
                      <a:r>
                        <a:rPr lang="en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interface</a:t>
                      </a: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-S:8H12:VacW-209</a:t>
                      </a:r>
                      <a:endParaRPr lang="en" altLang="zh-C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6599179"/>
                  </a:ext>
                </a:extLst>
              </a:tr>
              <a:tr h="368587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 Collection and processing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3748747"/>
                  </a:ext>
                </a:extLst>
              </a:tr>
              <a:tr h="120904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scope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 F30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 F30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 F30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 F30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 F30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altLang="zh-CN" sz="7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cnai</a:t>
                      </a:r>
                      <a:r>
                        <a:rPr lang="en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30</a:t>
                      </a:r>
                      <a:endParaRPr lang="en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655959"/>
                  </a:ext>
                </a:extLst>
              </a:tr>
              <a:tr h="120904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mera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con 3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lcon 3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3</a:t>
                      </a:r>
                      <a:endParaRPr lang="e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1925955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tage (kV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3303065"/>
                  </a:ext>
                </a:extLst>
              </a:tr>
              <a:tr h="283527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ectron exposure dose (e</a:t>
                      </a:r>
                      <a:r>
                        <a:rPr lang="en" sz="700" u="none" strike="noStrike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Å</a:t>
                      </a:r>
                      <a:r>
                        <a:rPr lang="en" sz="700" u="none" strike="noStrike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2023958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ocus range (</a:t>
                      </a:r>
                      <a:r>
                        <a:rPr lang="el-GR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-2.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-1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-1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-2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9-1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9-1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-2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0-2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-2.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.1-2.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-1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1504495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xel size (Å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0.7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4358360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graphs (used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7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,03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8,45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,2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,86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23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07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,47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8,18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,90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,73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0591140"/>
                  </a:ext>
                </a:extLst>
              </a:tr>
              <a:tr h="23649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nal particle images (nos.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5,71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7,36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60,02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60,028</a:t>
                      </a: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34,55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7,06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7,83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17,83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78,41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66,24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95,08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95,08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211,24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11,24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07,06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7,06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3,5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624998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metry imposed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554186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 resolution (Å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7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5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6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8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9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5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5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9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4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4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4.0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9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7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1341670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C threshold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  <a:endParaRPr lang="en-US" altLang="zh-CN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448480"/>
                  </a:ext>
                </a:extLst>
              </a:tr>
              <a:tr h="283527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 sharpening B factor (Å</a:t>
                      </a:r>
                      <a:r>
                        <a:rPr lang="en" sz="700" u="none" strike="noStrike" baseline="30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440.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722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8.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25.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1.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18.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89.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05.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4.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5.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210.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96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58.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79.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108.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-60.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0690794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idation</a:t>
                      </a:r>
                      <a:endParaRPr lang="en" sz="7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49852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Probity score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7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6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5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76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2772098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r rotamers (%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9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7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54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1974437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hscore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1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1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3.1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5.4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6091146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S (bonds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7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5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5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.005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7277732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S (angles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09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1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1.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7279932"/>
                  </a:ext>
                </a:extLst>
              </a:tr>
              <a:tr h="18429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machandran plot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7059996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Favored (%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2.1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3.8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3.22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92.63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3724722"/>
                  </a:ext>
                </a:extLst>
              </a:tr>
              <a:tr h="178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Allowed (%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8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15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6.78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7.37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/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0158085"/>
                  </a:ext>
                </a:extLst>
              </a:tr>
              <a:tr h="19138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7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Disallowed (%)</a:t>
                      </a:r>
                      <a:endParaRPr lang="en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zh-CN" altLang="en-US" sz="7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　</a:t>
                      </a:r>
                      <a:endParaRPr lang="zh-CN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906" marR="4906" marT="4906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0714418"/>
                  </a:ext>
                </a:extLst>
              </a:tr>
            </a:tbl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84D77B61-AB9C-3742-8DBD-C0A378B53B6C}"/>
              </a:ext>
            </a:extLst>
          </p:cNvPr>
          <p:cNvSpPr/>
          <p:nvPr/>
        </p:nvSpPr>
        <p:spPr>
          <a:xfrm>
            <a:off x="-62754" y="86962"/>
            <a:ext cx="758414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2. Cryo-EM data collection, refinement and validation statistics of immune-complexes </a:t>
            </a:r>
            <a:endParaRPr lang="en-US" altLang="zh-CN" sz="12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7740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533</Words>
  <Application>Microsoft Macintosh PowerPoint</Application>
  <PresentationFormat>A4 纸张(210x297 毫米)</PresentationFormat>
  <Paragraphs>39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i Sun</dc:creator>
  <cp:lastModifiedBy>Hui Sun</cp:lastModifiedBy>
  <cp:revision>19</cp:revision>
  <dcterms:created xsi:type="dcterms:W3CDTF">2022-10-18T06:38:07Z</dcterms:created>
  <dcterms:modified xsi:type="dcterms:W3CDTF">2023-03-23T07:04:33Z</dcterms:modified>
</cp:coreProperties>
</file>